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702" userDrawn="1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1FECB4D8-DB02-4DC6-A0A2-4F2EBAE1DC90}" styleName="Medium Style 1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207"/>
    <p:restoredTop sz="96292"/>
  </p:normalViewPr>
  <p:slideViewPr>
    <p:cSldViewPr snapToGrid="0" snapToObjects="1" showGuides="1">
      <p:cViewPr>
        <p:scale>
          <a:sx n="82" d="100"/>
          <a:sy n="82" d="100"/>
        </p:scale>
        <p:origin x="2072" y="1656"/>
      </p:cViewPr>
      <p:guideLst>
        <p:guide orient="horz" pos="3702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FC5DA0-7AC1-0B48-B377-BAFD2409CDF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F48363B-56C1-4F40-805A-F30D3A14AF9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E059D9-8189-DB48-BC94-FCEA38149C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8D8C7-51FE-5346-A3AD-F0EAC7CDA069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D927C1-F6B0-4F41-9A13-E1F6684772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8C0CF3-AB5E-2448-9AF9-0542B8495E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99881-29BB-2D45-8392-1911E21D4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82836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5AE2D6-C151-D14D-8EC2-2DECB3AD29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26C9A98-E470-8C4A-93CC-DB87881869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4AF9DA-FBBC-4043-9D31-D1479997DD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8D8C7-51FE-5346-A3AD-F0EAC7CDA069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394082-D11D-6C47-8688-7FABF13914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F08255-3D28-0C40-9278-EA74486E1C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99881-29BB-2D45-8392-1911E21D4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6174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266976E-8395-004A-96AD-BEA30640191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61F1F0C-1729-954C-B704-5B8FFE527E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8FDE06-74B1-BD49-B905-809CBB6EF2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8D8C7-51FE-5346-A3AD-F0EAC7CDA069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3476E6-4BB2-1446-85AC-38057D71CB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F20086-4123-1241-B29C-B9E33666DB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99881-29BB-2D45-8392-1911E21D4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64093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842EA1-04DE-FE44-9500-ECE2255456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840CDD-A4A7-4B47-A6E6-E6B7DBB5387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057B6A-9DE4-BB43-94ED-582924830A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8D8C7-51FE-5346-A3AD-F0EAC7CDA069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D75733-9B12-AA41-8AD7-8491150952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871615-E8A7-BF48-A93A-77EFE4107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99881-29BB-2D45-8392-1911E21D4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7344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4DB0BC-F85C-3E4E-8E4C-EFA6F26D9C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1A3B632-0536-9547-ABDD-3D5FDB036E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9FD4D8-0855-F341-93E6-B17019D809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8D8C7-51FE-5346-A3AD-F0EAC7CDA069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F43083-86A0-684E-9305-1F1DD658E1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253F4E-C021-0F49-B0E0-B0FE8A7680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99881-29BB-2D45-8392-1911E21D4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4983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34CFCC-035C-EA4A-AE76-45B2939779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AF29BE-35BA-CB41-B265-A5CE038D4A1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1748875-06B7-4140-A7A5-5E478F1BAD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78C56E-FCE7-BD45-9F0D-A41C36E08F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8D8C7-51FE-5346-A3AD-F0EAC7CDA069}" type="datetimeFigureOut">
              <a:rPr lang="en-US" smtClean="0"/>
              <a:t>2/2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F19580A-A380-B24F-A9D2-5A678E805E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A800D7-7BBD-C44D-8C66-7D8B99541E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99881-29BB-2D45-8392-1911E21D4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86309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DB02B3-7FF8-1D48-9DEF-726FC9149F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9AD3C6A-2AB7-E24E-B9E1-2B3E8DDA6D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378A67C-6BE7-4C4A-B93C-73BFAEACAD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2B04B95-99C6-A04A-8D49-8237ECA3ACB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C051EFA-3EB0-8F49-91E6-03DAD6D5861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0EA70D2-FEF0-E94C-9DE7-FB03B38186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8D8C7-51FE-5346-A3AD-F0EAC7CDA069}" type="datetimeFigureOut">
              <a:rPr lang="en-US" smtClean="0"/>
              <a:t>2/21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D5B7780-9202-6B4E-8640-2983C7BFAA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D3A17C0-3337-2D4F-85BD-20D90E2A35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99881-29BB-2D45-8392-1911E21D4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8889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72063D-A8D3-594F-9515-AA1612099A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A7B96A6-4F6A-F141-902F-BFFF9D07ED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8D8C7-51FE-5346-A3AD-F0EAC7CDA069}" type="datetimeFigureOut">
              <a:rPr lang="en-US" smtClean="0"/>
              <a:t>2/21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94A68DB-6C44-6A4C-94D0-521952C224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58B3FC9-34FC-D841-81C4-75ECC9E18E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99881-29BB-2D45-8392-1911E21D4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15906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C353B51-230F-624F-8F62-D11FDB4DED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8D8C7-51FE-5346-A3AD-F0EAC7CDA069}" type="datetimeFigureOut">
              <a:rPr lang="en-US" smtClean="0"/>
              <a:t>2/21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7040424-DD90-784F-9441-629177FB6C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3203E6B-E8C3-9A4F-A7EB-A5FA79B6F4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99881-29BB-2D45-8392-1911E21D4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82160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202FFF-4AA8-CE46-868C-C0E2941593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84E5C7-AD84-F648-983E-AD56682D0EC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05A557D-154B-3D44-A184-9DA8D07548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0DBFE67-14DD-3748-9D32-B3BC79058D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8D8C7-51FE-5346-A3AD-F0EAC7CDA069}" type="datetimeFigureOut">
              <a:rPr lang="en-US" smtClean="0"/>
              <a:t>2/2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D1BAA9-84F1-794B-AF4A-E7026BDF68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6FC542-4371-504C-B5F3-44A524BFF3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99881-29BB-2D45-8392-1911E21D4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60944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74B578-2D1C-6348-A801-CE2EBEEA23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3CB9E4B-1868-A344-8CAD-C28EC30836F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4BA7AC1-0F5E-D64E-8619-E290622473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15FA421-3FD6-6B46-A20E-F48494397C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8D8C7-51FE-5346-A3AD-F0EAC7CDA069}" type="datetimeFigureOut">
              <a:rPr lang="en-US" smtClean="0"/>
              <a:t>2/2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2D5E854-46A2-814A-BFD9-27882F57D1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1EDFDD4-91B3-2949-A737-A6840F9EB0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99881-29BB-2D45-8392-1911E21D4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32987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3523739-1F1E-274A-AD2A-7110A472CB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46542C-9099-374E-BAF8-8656AC08AE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D0E234-C030-E74B-9662-9ACD8B34FDE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88D8C7-51FE-5346-A3AD-F0EAC7CDA069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A1DF6B-5498-1145-AA5D-FC7B97FD6D3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A1EB75-DC2E-BB4B-98F3-E751BFF6F7C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B99881-29BB-2D45-8392-1911E21D4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8049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0CC2831A-9196-094E-A1E7-0D39366E452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62879462"/>
              </p:ext>
            </p:extLst>
          </p:nvPr>
        </p:nvGraphicFramePr>
        <p:xfrm>
          <a:off x="874878" y="1348888"/>
          <a:ext cx="4811548" cy="3723176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3089444">
                  <a:extLst>
                    <a:ext uri="{9D8B030D-6E8A-4147-A177-3AD203B41FA5}">
                      <a16:colId xmlns:a16="http://schemas.microsoft.com/office/drawing/2014/main" val="2480142395"/>
                    </a:ext>
                  </a:extLst>
                </a:gridCol>
                <a:gridCol w="1722104">
                  <a:extLst>
                    <a:ext uri="{9D8B030D-6E8A-4147-A177-3AD203B41FA5}">
                      <a16:colId xmlns:a16="http://schemas.microsoft.com/office/drawing/2014/main" val="3601361134"/>
                    </a:ext>
                  </a:extLst>
                </a:gridCol>
              </a:tblGrid>
              <a:tr h="419194"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>
                          <a:effectLst/>
                        </a:rPr>
                        <a:t>Species</a:t>
                      </a:r>
                      <a:endParaRPr lang="en-GB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>
                          <a:effectLst/>
                        </a:rPr>
                        <a:t>Isolates (n)</a:t>
                      </a:r>
                      <a:endParaRPr lang="en-GB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27499529"/>
                  </a:ext>
                </a:extLst>
              </a:tr>
              <a:tr h="409280">
                <a:tc>
                  <a:txBody>
                    <a:bodyPr/>
                    <a:lstStyle/>
                    <a:p>
                      <a:pPr algn="ctr"/>
                      <a:r>
                        <a:rPr lang="en-GB" sz="1200" i="1" dirty="0">
                          <a:effectLst/>
                        </a:rPr>
                        <a:t>Actinobacillus </a:t>
                      </a:r>
                      <a:r>
                        <a:rPr lang="en-GB" sz="1200" i="1" dirty="0" err="1">
                          <a:effectLst/>
                        </a:rPr>
                        <a:t>equuli</a:t>
                      </a:r>
                      <a:endParaRPr lang="en-GB" sz="12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>
                          <a:effectLst/>
                        </a:rPr>
                        <a:t>4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014700346"/>
                  </a:ext>
                </a:extLst>
              </a:tr>
              <a:tr h="409280">
                <a:tc>
                  <a:txBody>
                    <a:bodyPr/>
                    <a:lstStyle/>
                    <a:p>
                      <a:pPr algn="ctr"/>
                      <a:r>
                        <a:rPr lang="en-GB" sz="1200" i="1" dirty="0">
                          <a:effectLst/>
                        </a:rPr>
                        <a:t>“Actinobacillus </a:t>
                      </a:r>
                      <a:r>
                        <a:rPr lang="en-GB" sz="1200" i="1" dirty="0" err="1">
                          <a:effectLst/>
                        </a:rPr>
                        <a:t>porcitonsilarium</a:t>
                      </a:r>
                      <a:r>
                        <a:rPr lang="en-GB" sz="1200" i="1" dirty="0">
                          <a:effectLst/>
                        </a:rPr>
                        <a:t>”</a:t>
                      </a:r>
                      <a:endParaRPr lang="en-GB" sz="12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>
                          <a:effectLst/>
                        </a:rPr>
                        <a:t>4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631906676"/>
                  </a:ext>
                </a:extLst>
              </a:tr>
              <a:tr h="409280">
                <a:tc>
                  <a:txBody>
                    <a:bodyPr/>
                    <a:lstStyle/>
                    <a:p>
                      <a:pPr algn="ctr"/>
                      <a:r>
                        <a:rPr lang="en-GB" sz="1200" i="1" dirty="0">
                          <a:effectLst/>
                        </a:rPr>
                        <a:t>Actinobacillus suis</a:t>
                      </a:r>
                      <a:endParaRPr lang="en-GB" sz="12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>
                          <a:effectLst/>
                        </a:rPr>
                        <a:t>3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12861680"/>
                  </a:ext>
                </a:extLst>
              </a:tr>
              <a:tr h="409280">
                <a:tc>
                  <a:txBody>
                    <a:bodyPr/>
                    <a:lstStyle/>
                    <a:p>
                      <a:pPr algn="ctr"/>
                      <a:r>
                        <a:rPr lang="en-GB" sz="1200" i="1" dirty="0" err="1">
                          <a:effectLst/>
                        </a:rPr>
                        <a:t>Glaesserlla</a:t>
                      </a:r>
                      <a:r>
                        <a:rPr lang="en-GB" sz="1200" i="1" dirty="0">
                          <a:effectLst/>
                        </a:rPr>
                        <a:t> </a:t>
                      </a:r>
                      <a:r>
                        <a:rPr lang="en-GB" sz="1200" i="1" dirty="0" err="1">
                          <a:effectLst/>
                        </a:rPr>
                        <a:t>parasuis</a:t>
                      </a:r>
                      <a:endParaRPr lang="en-GB" sz="12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>
                          <a:effectLst/>
                        </a:rPr>
                        <a:t>3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450800888"/>
                  </a:ext>
                </a:extLst>
              </a:tr>
              <a:tr h="409280">
                <a:tc>
                  <a:txBody>
                    <a:bodyPr/>
                    <a:lstStyle/>
                    <a:p>
                      <a:pPr algn="ctr"/>
                      <a:r>
                        <a:rPr lang="en-GB" sz="1200" i="1" dirty="0">
                          <a:effectLst/>
                        </a:rPr>
                        <a:t>Mycoplasma </a:t>
                      </a:r>
                      <a:r>
                        <a:rPr lang="en-GB" sz="1200" i="1" dirty="0" err="1">
                          <a:effectLst/>
                        </a:rPr>
                        <a:t>hyopneumoniae</a:t>
                      </a:r>
                      <a:endParaRPr lang="en-GB" sz="12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>
                          <a:effectLst/>
                        </a:rPr>
                        <a:t>3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660567170"/>
                  </a:ext>
                </a:extLst>
              </a:tr>
              <a:tr h="419194">
                <a:tc>
                  <a:txBody>
                    <a:bodyPr/>
                    <a:lstStyle/>
                    <a:p>
                      <a:pPr algn="ctr"/>
                      <a:r>
                        <a:rPr lang="en-GB" sz="1200" i="1" dirty="0">
                          <a:effectLst/>
                        </a:rPr>
                        <a:t>Pasteurella </a:t>
                      </a:r>
                      <a:r>
                        <a:rPr lang="en-GB" sz="1200" i="1" dirty="0" err="1">
                          <a:effectLst/>
                        </a:rPr>
                        <a:t>multocida</a:t>
                      </a:r>
                      <a:endParaRPr lang="en-GB" sz="12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>
                          <a:effectLst/>
                        </a:rPr>
                        <a:t>4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372825420"/>
                  </a:ext>
                </a:extLst>
              </a:tr>
              <a:tr h="419194">
                <a:tc>
                  <a:txBody>
                    <a:bodyPr/>
                    <a:lstStyle/>
                    <a:p>
                      <a:pPr algn="ctr"/>
                      <a:r>
                        <a:rPr lang="en-GB" sz="1200" i="1" dirty="0">
                          <a:effectLst/>
                        </a:rPr>
                        <a:t>Pasteurella </a:t>
                      </a:r>
                      <a:r>
                        <a:rPr lang="en-GB" sz="1200" i="1" dirty="0" err="1">
                          <a:effectLst/>
                        </a:rPr>
                        <a:t>pneumotropica</a:t>
                      </a:r>
                      <a:endParaRPr lang="en-GB" sz="12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>
                          <a:effectLst/>
                        </a:rPr>
                        <a:t>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71636792"/>
                  </a:ext>
                </a:extLst>
              </a:tr>
              <a:tr h="419194">
                <a:tc>
                  <a:txBody>
                    <a:bodyPr/>
                    <a:lstStyle/>
                    <a:p>
                      <a:pPr algn="ctr"/>
                      <a:r>
                        <a:rPr lang="en-GB" sz="1200" i="1" dirty="0">
                          <a:effectLst/>
                        </a:rPr>
                        <a:t>Streptococcus </a:t>
                      </a:r>
                      <a:r>
                        <a:rPr lang="en-GB" sz="1200" i="1" dirty="0" err="1">
                          <a:effectLst/>
                        </a:rPr>
                        <a:t>suis</a:t>
                      </a:r>
                      <a:endParaRPr lang="en-GB" sz="12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effectLst/>
                        </a:rPr>
                        <a:t>4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588164962"/>
                  </a:ext>
                </a:extLst>
              </a:tr>
            </a:tbl>
          </a:graphicData>
        </a:graphic>
      </p:graphicFrame>
      <p:sp>
        <p:nvSpPr>
          <p:cNvPr id="5" name="Rectangle 4">
            <a:extLst>
              <a:ext uri="{FF2B5EF4-FFF2-40B4-BE49-F238E27FC236}">
                <a16:creationId xmlns:a16="http://schemas.microsoft.com/office/drawing/2014/main" id="{DC1985D9-B96E-1446-881F-9160CA937D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74877" y="738654"/>
            <a:ext cx="5327228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1.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pecies tested against APP-RPA in specificity experiments.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606732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9B647A6D-5F17-C84D-AF83-E60F2B3E9C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14405"/>
            <a:ext cx="12192000" cy="3114595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B0D91006-75FB-834B-881B-A515A73774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3705387"/>
            <a:ext cx="12213032" cy="1015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.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raphical depiction of </a:t>
            </a: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pxIVA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locus of isolates with untypical </a:t>
            </a: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pxIVA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gene arrangement.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IDG2311 contains two hypothetical proteins in opposite directions dispersing a partial duplication of </a:t>
            </a:r>
            <a:r>
              <a:rPr lang="en-US" altLang="en-US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pxIVA</a:t>
            </a:r>
            <a:r>
              <a:rPr lang="en-US" alt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denoted as </a:t>
            </a:r>
            <a:r>
              <a:rPr lang="en-US" altLang="en-US" sz="1200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pxIVSS</a:t>
            </a:r>
            <a:r>
              <a:rPr lang="en-US" alt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IDG3396 contains a transposable element, WP_005599960, flanked by a partial duplication of </a:t>
            </a: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pxIVA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denoted </a:t>
            </a:r>
            <a:r>
              <a:rPr kumimoji="0" lang="en-US" altLang="en-US" sz="1200" b="0" i="1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pxIVS</a:t>
            </a: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’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a </a:t>
            </a:r>
            <a:r>
              <a:rPr lang="en-US" alt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ragmented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pxIVA </a:t>
            </a:r>
            <a:r>
              <a:rPr kumimoji="0" lang="en-US" altLang="en-US" sz="12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ne containing three open reading frames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MIDG2206 contains a hypothetical protein</a:t>
            </a:r>
            <a:r>
              <a:rPr lang="en-US" alt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WP-017357847, 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etween </a:t>
            </a: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acZ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pxIVA</a:t>
            </a:r>
            <a:r>
              <a:rPr kumimoji="0" lang="en-US" altLang="en-US" sz="12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Red arrows depict APP-RPA </a:t>
            </a:r>
            <a:r>
              <a:rPr kumimoji="0" lang="en-US" altLang="en-US" sz="1200" b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imier</a:t>
            </a:r>
            <a:r>
              <a:rPr kumimoji="0" lang="en-US" altLang="en-US" sz="12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binding sites, alternative binding sites may contain single-nucleotide polymorphisms (not shown).</a:t>
            </a:r>
            <a:endParaRPr kumimoji="0" lang="en-US" altLang="en-US" sz="1200" b="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939404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63</TotalTime>
  <Words>143</Words>
  <Application>Microsoft Macintosh PowerPoint</Application>
  <PresentationFormat>Widescreen</PresentationFormat>
  <Paragraphs>2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ringer, Ollie</dc:creator>
  <cp:lastModifiedBy>Stringer, Oliver</cp:lastModifiedBy>
  <cp:revision>16</cp:revision>
  <dcterms:created xsi:type="dcterms:W3CDTF">2021-08-20T08:51:03Z</dcterms:created>
  <dcterms:modified xsi:type="dcterms:W3CDTF">2022-02-22T09:09:11Z</dcterms:modified>
</cp:coreProperties>
</file>